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5"/>
  </p:notesMasterIdLst>
  <p:sldIdLst>
    <p:sldId id="272" r:id="rId2"/>
    <p:sldId id="271" r:id="rId3"/>
    <p:sldId id="273" r:id="rId4"/>
  </p:sldIdLst>
  <p:sldSz cx="6143625" cy="9018588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1"/>
    <a:srgbClr val="11213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176"/>
    <p:restoredTop sz="94585"/>
  </p:normalViewPr>
  <p:slideViewPr>
    <p:cSldViewPr snapToGrid="0" snapToObjects="1">
      <p:cViewPr>
        <p:scale>
          <a:sx n="105" d="100"/>
          <a:sy n="105" d="100"/>
        </p:scale>
        <p:origin x="2616" y="-4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47EE3CB-69DA-5843-8800-43C803AFABF6}" type="datetimeFigureOut">
              <a:rPr lang="it-IT" smtClean="0"/>
              <a:t>10/01/25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78075" y="1143000"/>
            <a:ext cx="21018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26FC41D-F75D-1441-9153-B40B233C6BE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27470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0772" y="1475959"/>
            <a:ext cx="5222081" cy="3139805"/>
          </a:xfrm>
        </p:spPr>
        <p:txBody>
          <a:bodyPr anchor="b"/>
          <a:lstStyle>
            <a:lvl1pPr algn="ctr">
              <a:defRPr sz="4031"/>
            </a:lvl1pPr>
          </a:lstStyle>
          <a:p>
            <a:r>
              <a:rPr lang="it-IT"/>
              <a:t>Fare clic per modificare sti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7953" y="4736847"/>
            <a:ext cx="4607719" cy="2177404"/>
          </a:xfrm>
        </p:spPr>
        <p:txBody>
          <a:bodyPr/>
          <a:lstStyle>
            <a:lvl1pPr marL="0" indent="0" algn="ctr">
              <a:buNone/>
              <a:defRPr sz="1613"/>
            </a:lvl1pPr>
            <a:lvl2pPr marL="307193" indent="0" algn="ctr">
              <a:buNone/>
              <a:defRPr sz="1344"/>
            </a:lvl2pPr>
            <a:lvl3pPr marL="614385" indent="0" algn="ctr">
              <a:buNone/>
              <a:defRPr sz="1209"/>
            </a:lvl3pPr>
            <a:lvl4pPr marL="921578" indent="0" algn="ctr">
              <a:buNone/>
              <a:defRPr sz="1075"/>
            </a:lvl4pPr>
            <a:lvl5pPr marL="1228771" indent="0" algn="ctr">
              <a:buNone/>
              <a:defRPr sz="1075"/>
            </a:lvl5pPr>
            <a:lvl6pPr marL="1535963" indent="0" algn="ctr">
              <a:buNone/>
              <a:defRPr sz="1075"/>
            </a:lvl6pPr>
            <a:lvl7pPr marL="1843156" indent="0" algn="ctr">
              <a:buNone/>
              <a:defRPr sz="1075"/>
            </a:lvl7pPr>
            <a:lvl8pPr marL="2150349" indent="0" algn="ctr">
              <a:buNone/>
              <a:defRPr sz="1075"/>
            </a:lvl8pPr>
            <a:lvl9pPr marL="2457541" indent="0" algn="ctr">
              <a:buNone/>
              <a:defRPr sz="1075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9C227-F75A-EB40-9A8E-14F7A23F447B}" type="datetimeFigureOut">
              <a:rPr lang="it-IT" smtClean="0"/>
              <a:t>10/01/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D29646-44EB-D249-B8B8-E3416AD24A3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404823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sti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9C227-F75A-EB40-9A8E-14F7A23F447B}" type="datetimeFigureOut">
              <a:rPr lang="it-IT" smtClean="0"/>
              <a:t>10/01/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D29646-44EB-D249-B8B8-E3416AD24A3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78728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96532" y="480157"/>
            <a:ext cx="1324719" cy="7642836"/>
          </a:xfrm>
        </p:spPr>
        <p:txBody>
          <a:bodyPr vert="eaVert"/>
          <a:lstStyle/>
          <a:p>
            <a:r>
              <a:rPr lang="it-IT"/>
              <a:t>Fare clic per modificare sti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2375" y="480157"/>
            <a:ext cx="3897362" cy="7642836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9C227-F75A-EB40-9A8E-14F7A23F447B}" type="datetimeFigureOut">
              <a:rPr lang="it-IT" smtClean="0"/>
              <a:t>10/01/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D29646-44EB-D249-B8B8-E3416AD24A3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830340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sti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9C227-F75A-EB40-9A8E-14F7A23F447B}" type="datetimeFigureOut">
              <a:rPr lang="it-IT" smtClean="0"/>
              <a:t>10/01/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D29646-44EB-D249-B8B8-E3416AD24A3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034349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9175" y="2248387"/>
            <a:ext cx="5298877" cy="3751481"/>
          </a:xfrm>
        </p:spPr>
        <p:txBody>
          <a:bodyPr anchor="b"/>
          <a:lstStyle>
            <a:lvl1pPr>
              <a:defRPr sz="4031"/>
            </a:lvl1pPr>
          </a:lstStyle>
          <a:p>
            <a:r>
              <a:rPr lang="it-IT"/>
              <a:t>Fare clic per modificare sti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9175" y="6035359"/>
            <a:ext cx="5298877" cy="1972815"/>
          </a:xfrm>
        </p:spPr>
        <p:txBody>
          <a:bodyPr/>
          <a:lstStyle>
            <a:lvl1pPr marL="0" indent="0">
              <a:buNone/>
              <a:defRPr sz="1613">
                <a:solidFill>
                  <a:schemeClr val="tx1"/>
                </a:solidFill>
              </a:defRPr>
            </a:lvl1pPr>
            <a:lvl2pPr marL="307193" indent="0">
              <a:buNone/>
              <a:defRPr sz="1344">
                <a:solidFill>
                  <a:schemeClr val="tx1">
                    <a:tint val="75000"/>
                  </a:schemeClr>
                </a:solidFill>
              </a:defRPr>
            </a:lvl2pPr>
            <a:lvl3pPr marL="614385" indent="0">
              <a:buNone/>
              <a:defRPr sz="1209">
                <a:solidFill>
                  <a:schemeClr val="tx1">
                    <a:tint val="75000"/>
                  </a:schemeClr>
                </a:solidFill>
              </a:defRPr>
            </a:lvl3pPr>
            <a:lvl4pPr marL="921578" indent="0">
              <a:buNone/>
              <a:defRPr sz="1075">
                <a:solidFill>
                  <a:schemeClr val="tx1">
                    <a:tint val="75000"/>
                  </a:schemeClr>
                </a:solidFill>
              </a:defRPr>
            </a:lvl4pPr>
            <a:lvl5pPr marL="1228771" indent="0">
              <a:buNone/>
              <a:defRPr sz="1075">
                <a:solidFill>
                  <a:schemeClr val="tx1">
                    <a:tint val="75000"/>
                  </a:schemeClr>
                </a:solidFill>
              </a:defRPr>
            </a:lvl5pPr>
            <a:lvl6pPr marL="1535963" indent="0">
              <a:buNone/>
              <a:defRPr sz="1075">
                <a:solidFill>
                  <a:schemeClr val="tx1">
                    <a:tint val="75000"/>
                  </a:schemeClr>
                </a:solidFill>
              </a:defRPr>
            </a:lvl6pPr>
            <a:lvl7pPr marL="1843156" indent="0">
              <a:buNone/>
              <a:defRPr sz="1075">
                <a:solidFill>
                  <a:schemeClr val="tx1">
                    <a:tint val="75000"/>
                  </a:schemeClr>
                </a:solidFill>
              </a:defRPr>
            </a:lvl7pPr>
            <a:lvl8pPr marL="2150349" indent="0">
              <a:buNone/>
              <a:defRPr sz="1075">
                <a:solidFill>
                  <a:schemeClr val="tx1">
                    <a:tint val="75000"/>
                  </a:schemeClr>
                </a:solidFill>
              </a:defRPr>
            </a:lvl8pPr>
            <a:lvl9pPr marL="2457541" indent="0">
              <a:buNone/>
              <a:defRPr sz="107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9C227-F75A-EB40-9A8E-14F7A23F447B}" type="datetimeFigureOut">
              <a:rPr lang="it-IT" smtClean="0"/>
              <a:t>10/01/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D29646-44EB-D249-B8B8-E3416AD24A3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81957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sti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2374" y="2400782"/>
            <a:ext cx="2611041" cy="5722211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10210" y="2400782"/>
            <a:ext cx="2611041" cy="5722211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9C227-F75A-EB40-9A8E-14F7A23F447B}" type="datetimeFigureOut">
              <a:rPr lang="it-IT" smtClean="0"/>
              <a:t>10/01/2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D29646-44EB-D249-B8B8-E3416AD24A3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11480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3174" y="480158"/>
            <a:ext cx="5298877" cy="1743177"/>
          </a:xfrm>
        </p:spPr>
        <p:txBody>
          <a:bodyPr/>
          <a:lstStyle/>
          <a:p>
            <a:r>
              <a:rPr lang="it-IT"/>
              <a:t>Fare clic per modificare sti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3175" y="2210808"/>
            <a:ext cx="2599041" cy="1083482"/>
          </a:xfrm>
        </p:spPr>
        <p:txBody>
          <a:bodyPr anchor="b"/>
          <a:lstStyle>
            <a:lvl1pPr marL="0" indent="0">
              <a:buNone/>
              <a:defRPr sz="1613" b="1"/>
            </a:lvl1pPr>
            <a:lvl2pPr marL="307193" indent="0">
              <a:buNone/>
              <a:defRPr sz="1344" b="1"/>
            </a:lvl2pPr>
            <a:lvl3pPr marL="614385" indent="0">
              <a:buNone/>
              <a:defRPr sz="1209" b="1"/>
            </a:lvl3pPr>
            <a:lvl4pPr marL="921578" indent="0">
              <a:buNone/>
              <a:defRPr sz="1075" b="1"/>
            </a:lvl4pPr>
            <a:lvl5pPr marL="1228771" indent="0">
              <a:buNone/>
              <a:defRPr sz="1075" b="1"/>
            </a:lvl5pPr>
            <a:lvl6pPr marL="1535963" indent="0">
              <a:buNone/>
              <a:defRPr sz="1075" b="1"/>
            </a:lvl6pPr>
            <a:lvl7pPr marL="1843156" indent="0">
              <a:buNone/>
              <a:defRPr sz="1075" b="1"/>
            </a:lvl7pPr>
            <a:lvl8pPr marL="2150349" indent="0">
              <a:buNone/>
              <a:defRPr sz="1075" b="1"/>
            </a:lvl8pPr>
            <a:lvl9pPr marL="2457541" indent="0">
              <a:buNone/>
              <a:defRPr sz="1075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3175" y="3294290"/>
            <a:ext cx="2599041" cy="4845404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10210" y="2210808"/>
            <a:ext cx="2611841" cy="1083482"/>
          </a:xfrm>
        </p:spPr>
        <p:txBody>
          <a:bodyPr anchor="b"/>
          <a:lstStyle>
            <a:lvl1pPr marL="0" indent="0">
              <a:buNone/>
              <a:defRPr sz="1613" b="1"/>
            </a:lvl1pPr>
            <a:lvl2pPr marL="307193" indent="0">
              <a:buNone/>
              <a:defRPr sz="1344" b="1"/>
            </a:lvl2pPr>
            <a:lvl3pPr marL="614385" indent="0">
              <a:buNone/>
              <a:defRPr sz="1209" b="1"/>
            </a:lvl3pPr>
            <a:lvl4pPr marL="921578" indent="0">
              <a:buNone/>
              <a:defRPr sz="1075" b="1"/>
            </a:lvl4pPr>
            <a:lvl5pPr marL="1228771" indent="0">
              <a:buNone/>
              <a:defRPr sz="1075" b="1"/>
            </a:lvl5pPr>
            <a:lvl6pPr marL="1535963" indent="0">
              <a:buNone/>
              <a:defRPr sz="1075" b="1"/>
            </a:lvl6pPr>
            <a:lvl7pPr marL="1843156" indent="0">
              <a:buNone/>
              <a:defRPr sz="1075" b="1"/>
            </a:lvl7pPr>
            <a:lvl8pPr marL="2150349" indent="0">
              <a:buNone/>
              <a:defRPr sz="1075" b="1"/>
            </a:lvl8pPr>
            <a:lvl9pPr marL="2457541" indent="0">
              <a:buNone/>
              <a:defRPr sz="1075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10210" y="3294290"/>
            <a:ext cx="2611841" cy="4845404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9C227-F75A-EB40-9A8E-14F7A23F447B}" type="datetimeFigureOut">
              <a:rPr lang="it-IT" smtClean="0"/>
              <a:t>10/01/25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D29646-44EB-D249-B8B8-E3416AD24A3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220562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sti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9C227-F75A-EB40-9A8E-14F7A23F447B}" type="datetimeFigureOut">
              <a:rPr lang="it-IT" smtClean="0"/>
              <a:t>10/01/25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D29646-44EB-D249-B8B8-E3416AD24A3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447835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9C227-F75A-EB40-9A8E-14F7A23F447B}" type="datetimeFigureOut">
              <a:rPr lang="it-IT" smtClean="0"/>
              <a:t>10/01/25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D29646-44EB-D249-B8B8-E3416AD24A3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592070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3174" y="601239"/>
            <a:ext cx="1981479" cy="2104337"/>
          </a:xfrm>
        </p:spPr>
        <p:txBody>
          <a:bodyPr anchor="b"/>
          <a:lstStyle>
            <a:lvl1pPr>
              <a:defRPr sz="2150"/>
            </a:lvl1pPr>
          </a:lstStyle>
          <a:p>
            <a:r>
              <a:rPr lang="it-IT"/>
              <a:t>Fare clic per modificare sti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11841" y="1298512"/>
            <a:ext cx="3110210" cy="6409043"/>
          </a:xfrm>
        </p:spPr>
        <p:txBody>
          <a:bodyPr/>
          <a:lstStyle>
            <a:lvl1pPr>
              <a:defRPr sz="2150"/>
            </a:lvl1pPr>
            <a:lvl2pPr>
              <a:defRPr sz="1881"/>
            </a:lvl2pPr>
            <a:lvl3pPr>
              <a:defRPr sz="1613"/>
            </a:lvl3pPr>
            <a:lvl4pPr>
              <a:defRPr sz="1344"/>
            </a:lvl4pPr>
            <a:lvl5pPr>
              <a:defRPr sz="1344"/>
            </a:lvl5pPr>
            <a:lvl6pPr>
              <a:defRPr sz="1344"/>
            </a:lvl6pPr>
            <a:lvl7pPr>
              <a:defRPr sz="1344"/>
            </a:lvl7pPr>
            <a:lvl8pPr>
              <a:defRPr sz="1344"/>
            </a:lvl8pPr>
            <a:lvl9pPr>
              <a:defRPr sz="1344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3174" y="2705576"/>
            <a:ext cx="1981479" cy="5012415"/>
          </a:xfrm>
        </p:spPr>
        <p:txBody>
          <a:bodyPr/>
          <a:lstStyle>
            <a:lvl1pPr marL="0" indent="0">
              <a:buNone/>
              <a:defRPr sz="1075"/>
            </a:lvl1pPr>
            <a:lvl2pPr marL="307193" indent="0">
              <a:buNone/>
              <a:defRPr sz="941"/>
            </a:lvl2pPr>
            <a:lvl3pPr marL="614385" indent="0">
              <a:buNone/>
              <a:defRPr sz="806"/>
            </a:lvl3pPr>
            <a:lvl4pPr marL="921578" indent="0">
              <a:buNone/>
              <a:defRPr sz="672"/>
            </a:lvl4pPr>
            <a:lvl5pPr marL="1228771" indent="0">
              <a:buNone/>
              <a:defRPr sz="672"/>
            </a:lvl5pPr>
            <a:lvl6pPr marL="1535963" indent="0">
              <a:buNone/>
              <a:defRPr sz="672"/>
            </a:lvl6pPr>
            <a:lvl7pPr marL="1843156" indent="0">
              <a:buNone/>
              <a:defRPr sz="672"/>
            </a:lvl7pPr>
            <a:lvl8pPr marL="2150349" indent="0">
              <a:buNone/>
              <a:defRPr sz="672"/>
            </a:lvl8pPr>
            <a:lvl9pPr marL="2457541" indent="0">
              <a:buNone/>
              <a:defRPr sz="672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9C227-F75A-EB40-9A8E-14F7A23F447B}" type="datetimeFigureOut">
              <a:rPr lang="it-IT" smtClean="0"/>
              <a:t>10/01/2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D29646-44EB-D249-B8B8-E3416AD24A3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171448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3174" y="601239"/>
            <a:ext cx="1981479" cy="2104337"/>
          </a:xfrm>
        </p:spPr>
        <p:txBody>
          <a:bodyPr anchor="b"/>
          <a:lstStyle>
            <a:lvl1pPr>
              <a:defRPr sz="2150"/>
            </a:lvl1pPr>
          </a:lstStyle>
          <a:p>
            <a:r>
              <a:rPr lang="it-IT"/>
              <a:t>Fare clic per modificare sti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11841" y="1298512"/>
            <a:ext cx="3110210" cy="6409043"/>
          </a:xfrm>
        </p:spPr>
        <p:txBody>
          <a:bodyPr anchor="t"/>
          <a:lstStyle>
            <a:lvl1pPr marL="0" indent="0">
              <a:buNone/>
              <a:defRPr sz="2150"/>
            </a:lvl1pPr>
            <a:lvl2pPr marL="307193" indent="0">
              <a:buNone/>
              <a:defRPr sz="1881"/>
            </a:lvl2pPr>
            <a:lvl3pPr marL="614385" indent="0">
              <a:buNone/>
              <a:defRPr sz="1613"/>
            </a:lvl3pPr>
            <a:lvl4pPr marL="921578" indent="0">
              <a:buNone/>
              <a:defRPr sz="1344"/>
            </a:lvl4pPr>
            <a:lvl5pPr marL="1228771" indent="0">
              <a:buNone/>
              <a:defRPr sz="1344"/>
            </a:lvl5pPr>
            <a:lvl6pPr marL="1535963" indent="0">
              <a:buNone/>
              <a:defRPr sz="1344"/>
            </a:lvl6pPr>
            <a:lvl7pPr marL="1843156" indent="0">
              <a:buNone/>
              <a:defRPr sz="1344"/>
            </a:lvl7pPr>
            <a:lvl8pPr marL="2150349" indent="0">
              <a:buNone/>
              <a:defRPr sz="1344"/>
            </a:lvl8pPr>
            <a:lvl9pPr marL="2457541" indent="0">
              <a:buNone/>
              <a:defRPr sz="1344"/>
            </a:lvl9pPr>
          </a:lstStyle>
          <a:p>
            <a:r>
              <a:rPr lang="it-IT"/>
              <a:t>Trascinare l'immagine su un segnaposto o fare clic sull'icona per aggiungerla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3174" y="2705576"/>
            <a:ext cx="1981479" cy="5012415"/>
          </a:xfrm>
        </p:spPr>
        <p:txBody>
          <a:bodyPr/>
          <a:lstStyle>
            <a:lvl1pPr marL="0" indent="0">
              <a:buNone/>
              <a:defRPr sz="1075"/>
            </a:lvl1pPr>
            <a:lvl2pPr marL="307193" indent="0">
              <a:buNone/>
              <a:defRPr sz="941"/>
            </a:lvl2pPr>
            <a:lvl3pPr marL="614385" indent="0">
              <a:buNone/>
              <a:defRPr sz="806"/>
            </a:lvl3pPr>
            <a:lvl4pPr marL="921578" indent="0">
              <a:buNone/>
              <a:defRPr sz="672"/>
            </a:lvl4pPr>
            <a:lvl5pPr marL="1228771" indent="0">
              <a:buNone/>
              <a:defRPr sz="672"/>
            </a:lvl5pPr>
            <a:lvl6pPr marL="1535963" indent="0">
              <a:buNone/>
              <a:defRPr sz="672"/>
            </a:lvl6pPr>
            <a:lvl7pPr marL="1843156" indent="0">
              <a:buNone/>
              <a:defRPr sz="672"/>
            </a:lvl7pPr>
            <a:lvl8pPr marL="2150349" indent="0">
              <a:buNone/>
              <a:defRPr sz="672"/>
            </a:lvl8pPr>
            <a:lvl9pPr marL="2457541" indent="0">
              <a:buNone/>
              <a:defRPr sz="672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9C227-F75A-EB40-9A8E-14F7A23F447B}" type="datetimeFigureOut">
              <a:rPr lang="it-IT" smtClean="0"/>
              <a:t>10/01/2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D29646-44EB-D249-B8B8-E3416AD24A3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710839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2374" y="480158"/>
            <a:ext cx="5298877" cy="174317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sti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2374" y="2400782"/>
            <a:ext cx="5298877" cy="572221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2374" y="8358897"/>
            <a:ext cx="1382316" cy="48015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39C227-F75A-EB40-9A8E-14F7A23F447B}" type="datetimeFigureOut">
              <a:rPr lang="it-IT" smtClean="0"/>
              <a:t>10/01/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35076" y="8358897"/>
            <a:ext cx="2073473" cy="48015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38935" y="8358897"/>
            <a:ext cx="1382316" cy="48015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D29646-44EB-D249-B8B8-E3416AD24A3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258137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14385" rtl="0" eaLnBrk="1" latinLnBrk="0" hangingPunct="1">
        <a:lnSpc>
          <a:spcPct val="90000"/>
        </a:lnSpc>
        <a:spcBef>
          <a:spcPct val="0"/>
        </a:spcBef>
        <a:buNone/>
        <a:defRPr sz="295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596" indent="-153596" algn="l" defTabSz="614385" rtl="0" eaLnBrk="1" latinLnBrk="0" hangingPunct="1">
        <a:lnSpc>
          <a:spcPct val="90000"/>
        </a:lnSpc>
        <a:spcBef>
          <a:spcPts val="672"/>
        </a:spcBef>
        <a:buFont typeface="Arial" panose="020B0604020202020204" pitchFamily="34" charset="0"/>
        <a:buChar char="•"/>
        <a:defRPr sz="1881" kern="1200">
          <a:solidFill>
            <a:schemeClr val="tx1"/>
          </a:solidFill>
          <a:latin typeface="+mn-lt"/>
          <a:ea typeface="+mn-ea"/>
          <a:cs typeface="+mn-cs"/>
        </a:defRPr>
      </a:lvl1pPr>
      <a:lvl2pPr marL="460789" indent="-153596" algn="l" defTabSz="614385" rtl="0" eaLnBrk="1" latinLnBrk="0" hangingPunct="1">
        <a:lnSpc>
          <a:spcPct val="90000"/>
        </a:lnSpc>
        <a:spcBef>
          <a:spcPts val="336"/>
        </a:spcBef>
        <a:buFont typeface="Arial" panose="020B0604020202020204" pitchFamily="34" charset="0"/>
        <a:buChar char="•"/>
        <a:defRPr sz="1613" kern="1200">
          <a:solidFill>
            <a:schemeClr val="tx1"/>
          </a:solidFill>
          <a:latin typeface="+mn-lt"/>
          <a:ea typeface="+mn-ea"/>
          <a:cs typeface="+mn-cs"/>
        </a:defRPr>
      </a:lvl2pPr>
      <a:lvl3pPr marL="767982" indent="-153596" algn="l" defTabSz="614385" rtl="0" eaLnBrk="1" latinLnBrk="0" hangingPunct="1">
        <a:lnSpc>
          <a:spcPct val="90000"/>
        </a:lnSpc>
        <a:spcBef>
          <a:spcPts val="336"/>
        </a:spcBef>
        <a:buFont typeface="Arial" panose="020B0604020202020204" pitchFamily="34" charset="0"/>
        <a:buChar char="•"/>
        <a:defRPr sz="1344" kern="1200">
          <a:solidFill>
            <a:schemeClr val="tx1"/>
          </a:solidFill>
          <a:latin typeface="+mn-lt"/>
          <a:ea typeface="+mn-ea"/>
          <a:cs typeface="+mn-cs"/>
        </a:defRPr>
      </a:lvl3pPr>
      <a:lvl4pPr marL="1075174" indent="-153596" algn="l" defTabSz="614385" rtl="0" eaLnBrk="1" latinLnBrk="0" hangingPunct="1">
        <a:lnSpc>
          <a:spcPct val="90000"/>
        </a:lnSpc>
        <a:spcBef>
          <a:spcPts val="336"/>
        </a:spcBef>
        <a:buFont typeface="Arial" panose="020B0604020202020204" pitchFamily="34" charset="0"/>
        <a:buChar char="•"/>
        <a:defRPr sz="1209" kern="1200">
          <a:solidFill>
            <a:schemeClr val="tx1"/>
          </a:solidFill>
          <a:latin typeface="+mn-lt"/>
          <a:ea typeface="+mn-ea"/>
          <a:cs typeface="+mn-cs"/>
        </a:defRPr>
      </a:lvl4pPr>
      <a:lvl5pPr marL="1382367" indent="-153596" algn="l" defTabSz="614385" rtl="0" eaLnBrk="1" latinLnBrk="0" hangingPunct="1">
        <a:lnSpc>
          <a:spcPct val="90000"/>
        </a:lnSpc>
        <a:spcBef>
          <a:spcPts val="336"/>
        </a:spcBef>
        <a:buFont typeface="Arial" panose="020B0604020202020204" pitchFamily="34" charset="0"/>
        <a:buChar char="•"/>
        <a:defRPr sz="1209" kern="1200">
          <a:solidFill>
            <a:schemeClr val="tx1"/>
          </a:solidFill>
          <a:latin typeface="+mn-lt"/>
          <a:ea typeface="+mn-ea"/>
          <a:cs typeface="+mn-cs"/>
        </a:defRPr>
      </a:lvl5pPr>
      <a:lvl6pPr marL="1689560" indent="-153596" algn="l" defTabSz="614385" rtl="0" eaLnBrk="1" latinLnBrk="0" hangingPunct="1">
        <a:lnSpc>
          <a:spcPct val="90000"/>
        </a:lnSpc>
        <a:spcBef>
          <a:spcPts val="336"/>
        </a:spcBef>
        <a:buFont typeface="Arial" panose="020B0604020202020204" pitchFamily="34" charset="0"/>
        <a:buChar char="•"/>
        <a:defRPr sz="1209" kern="1200">
          <a:solidFill>
            <a:schemeClr val="tx1"/>
          </a:solidFill>
          <a:latin typeface="+mn-lt"/>
          <a:ea typeface="+mn-ea"/>
          <a:cs typeface="+mn-cs"/>
        </a:defRPr>
      </a:lvl6pPr>
      <a:lvl7pPr marL="1996752" indent="-153596" algn="l" defTabSz="614385" rtl="0" eaLnBrk="1" latinLnBrk="0" hangingPunct="1">
        <a:lnSpc>
          <a:spcPct val="90000"/>
        </a:lnSpc>
        <a:spcBef>
          <a:spcPts val="336"/>
        </a:spcBef>
        <a:buFont typeface="Arial" panose="020B0604020202020204" pitchFamily="34" charset="0"/>
        <a:buChar char="•"/>
        <a:defRPr sz="1209" kern="1200">
          <a:solidFill>
            <a:schemeClr val="tx1"/>
          </a:solidFill>
          <a:latin typeface="+mn-lt"/>
          <a:ea typeface="+mn-ea"/>
          <a:cs typeface="+mn-cs"/>
        </a:defRPr>
      </a:lvl7pPr>
      <a:lvl8pPr marL="2303945" indent="-153596" algn="l" defTabSz="614385" rtl="0" eaLnBrk="1" latinLnBrk="0" hangingPunct="1">
        <a:lnSpc>
          <a:spcPct val="90000"/>
        </a:lnSpc>
        <a:spcBef>
          <a:spcPts val="336"/>
        </a:spcBef>
        <a:buFont typeface="Arial" panose="020B0604020202020204" pitchFamily="34" charset="0"/>
        <a:buChar char="•"/>
        <a:defRPr sz="1209" kern="1200">
          <a:solidFill>
            <a:schemeClr val="tx1"/>
          </a:solidFill>
          <a:latin typeface="+mn-lt"/>
          <a:ea typeface="+mn-ea"/>
          <a:cs typeface="+mn-cs"/>
        </a:defRPr>
      </a:lvl8pPr>
      <a:lvl9pPr marL="2611138" indent="-153596" algn="l" defTabSz="614385" rtl="0" eaLnBrk="1" latinLnBrk="0" hangingPunct="1">
        <a:lnSpc>
          <a:spcPct val="90000"/>
        </a:lnSpc>
        <a:spcBef>
          <a:spcPts val="336"/>
        </a:spcBef>
        <a:buFont typeface="Arial" panose="020B0604020202020204" pitchFamily="34" charset="0"/>
        <a:buChar char="•"/>
        <a:defRPr sz="120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4385" rtl="0" eaLnBrk="1" latinLnBrk="0" hangingPunct="1">
        <a:defRPr sz="1209" kern="1200">
          <a:solidFill>
            <a:schemeClr val="tx1"/>
          </a:solidFill>
          <a:latin typeface="+mn-lt"/>
          <a:ea typeface="+mn-ea"/>
          <a:cs typeface="+mn-cs"/>
        </a:defRPr>
      </a:lvl1pPr>
      <a:lvl2pPr marL="307193" algn="l" defTabSz="614385" rtl="0" eaLnBrk="1" latinLnBrk="0" hangingPunct="1">
        <a:defRPr sz="1209" kern="1200">
          <a:solidFill>
            <a:schemeClr val="tx1"/>
          </a:solidFill>
          <a:latin typeface="+mn-lt"/>
          <a:ea typeface="+mn-ea"/>
          <a:cs typeface="+mn-cs"/>
        </a:defRPr>
      </a:lvl2pPr>
      <a:lvl3pPr marL="614385" algn="l" defTabSz="614385" rtl="0" eaLnBrk="1" latinLnBrk="0" hangingPunct="1">
        <a:defRPr sz="1209" kern="1200">
          <a:solidFill>
            <a:schemeClr val="tx1"/>
          </a:solidFill>
          <a:latin typeface="+mn-lt"/>
          <a:ea typeface="+mn-ea"/>
          <a:cs typeface="+mn-cs"/>
        </a:defRPr>
      </a:lvl3pPr>
      <a:lvl4pPr marL="921578" algn="l" defTabSz="614385" rtl="0" eaLnBrk="1" latinLnBrk="0" hangingPunct="1">
        <a:defRPr sz="1209" kern="1200">
          <a:solidFill>
            <a:schemeClr val="tx1"/>
          </a:solidFill>
          <a:latin typeface="+mn-lt"/>
          <a:ea typeface="+mn-ea"/>
          <a:cs typeface="+mn-cs"/>
        </a:defRPr>
      </a:lvl4pPr>
      <a:lvl5pPr marL="1228771" algn="l" defTabSz="614385" rtl="0" eaLnBrk="1" latinLnBrk="0" hangingPunct="1">
        <a:defRPr sz="1209" kern="1200">
          <a:solidFill>
            <a:schemeClr val="tx1"/>
          </a:solidFill>
          <a:latin typeface="+mn-lt"/>
          <a:ea typeface="+mn-ea"/>
          <a:cs typeface="+mn-cs"/>
        </a:defRPr>
      </a:lvl5pPr>
      <a:lvl6pPr marL="1535963" algn="l" defTabSz="614385" rtl="0" eaLnBrk="1" latinLnBrk="0" hangingPunct="1">
        <a:defRPr sz="1209" kern="1200">
          <a:solidFill>
            <a:schemeClr val="tx1"/>
          </a:solidFill>
          <a:latin typeface="+mn-lt"/>
          <a:ea typeface="+mn-ea"/>
          <a:cs typeface="+mn-cs"/>
        </a:defRPr>
      </a:lvl6pPr>
      <a:lvl7pPr marL="1843156" algn="l" defTabSz="614385" rtl="0" eaLnBrk="1" latinLnBrk="0" hangingPunct="1">
        <a:defRPr sz="1209" kern="1200">
          <a:solidFill>
            <a:schemeClr val="tx1"/>
          </a:solidFill>
          <a:latin typeface="+mn-lt"/>
          <a:ea typeface="+mn-ea"/>
          <a:cs typeface="+mn-cs"/>
        </a:defRPr>
      </a:lvl7pPr>
      <a:lvl8pPr marL="2150349" algn="l" defTabSz="614385" rtl="0" eaLnBrk="1" latinLnBrk="0" hangingPunct="1">
        <a:defRPr sz="1209" kern="1200">
          <a:solidFill>
            <a:schemeClr val="tx1"/>
          </a:solidFill>
          <a:latin typeface="+mn-lt"/>
          <a:ea typeface="+mn-ea"/>
          <a:cs typeface="+mn-cs"/>
        </a:defRPr>
      </a:lvl8pPr>
      <a:lvl9pPr marL="2457541" algn="l" defTabSz="614385" rtl="0" eaLnBrk="1" latinLnBrk="0" hangingPunct="1">
        <a:defRPr sz="120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sv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tif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 descr="Immagine che contiene neve, inverno&#10;&#10;Descrizione generata automaticamente">
            <a:extLst>
              <a:ext uri="{FF2B5EF4-FFF2-40B4-BE49-F238E27FC236}">
                <a16:creationId xmlns:a16="http://schemas.microsoft.com/office/drawing/2014/main" id="{105CC413-130F-BC78-C972-3186A9CC7D8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3122" y="2226733"/>
            <a:ext cx="4983843" cy="3802765"/>
          </a:xfrm>
          <a:prstGeom prst="rect">
            <a:avLst/>
          </a:prstGeom>
        </p:spPr>
      </p:pic>
      <p:pic>
        <p:nvPicPr>
          <p:cNvPr id="5" name="Elemento grafico 4" descr="Direzione con riempimento a tinta unita">
            <a:extLst>
              <a:ext uri="{FF2B5EF4-FFF2-40B4-BE49-F238E27FC236}">
                <a16:creationId xmlns:a16="http://schemas.microsoft.com/office/drawing/2014/main" id="{3E17C563-6BF3-1B3D-4FF4-78F7F5552F6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2698701" y="5308215"/>
            <a:ext cx="331794" cy="331794"/>
          </a:xfrm>
          <a:prstGeom prst="rect">
            <a:avLst/>
          </a:prstGeom>
        </p:spPr>
      </p:pic>
      <p:pic>
        <p:nvPicPr>
          <p:cNvPr id="7" name="Elemento grafico 6" descr="Direzione con riempimento a tinta unita">
            <a:extLst>
              <a:ext uri="{FF2B5EF4-FFF2-40B4-BE49-F238E27FC236}">
                <a16:creationId xmlns:a16="http://schemas.microsoft.com/office/drawing/2014/main" id="{FBF0F338-9917-BEC6-1D25-6F39B6B75F3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3495237" y="2950918"/>
            <a:ext cx="339535" cy="339535"/>
          </a:xfrm>
          <a:prstGeom prst="rect">
            <a:avLst/>
          </a:prstGeom>
        </p:spPr>
      </p:pic>
      <p:pic>
        <p:nvPicPr>
          <p:cNvPr id="9" name="Elemento grafico 8" descr="Direzione con riempimento a tinta unita">
            <a:extLst>
              <a:ext uri="{FF2B5EF4-FFF2-40B4-BE49-F238E27FC236}">
                <a16:creationId xmlns:a16="http://schemas.microsoft.com/office/drawing/2014/main" id="{FFE30ED6-692C-C21E-ACA1-8E8C9B6B6AF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1943626" y="3727684"/>
            <a:ext cx="379163" cy="379163"/>
          </a:xfrm>
          <a:prstGeom prst="rect">
            <a:avLst/>
          </a:prstGeom>
        </p:spPr>
      </p:pic>
      <p:sp>
        <p:nvSpPr>
          <p:cNvPr id="10" name="CasellaDiTesto 9">
            <a:extLst>
              <a:ext uri="{FF2B5EF4-FFF2-40B4-BE49-F238E27FC236}">
                <a16:creationId xmlns:a16="http://schemas.microsoft.com/office/drawing/2014/main" id="{D7068E42-0088-FDD4-0D0F-E375F0CE7100}"/>
              </a:ext>
            </a:extLst>
          </p:cNvPr>
          <p:cNvSpPr txBox="1"/>
          <p:nvPr/>
        </p:nvSpPr>
        <p:spPr>
          <a:xfrm>
            <a:off x="0" y="0"/>
            <a:ext cx="766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cs typeface="Calibri" panose="020F0502020204030204" pitchFamily="34" charset="0"/>
              </a:rPr>
              <a:t>Figure S1</a:t>
            </a:r>
          </a:p>
        </p:txBody>
      </p:sp>
    </p:spTree>
    <p:extLst>
      <p:ext uri="{BB962C8B-B14F-4D97-AF65-F5344CB8AC3E}">
        <p14:creationId xmlns:p14="http://schemas.microsoft.com/office/powerpoint/2010/main" val="3123524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Immagine 19" descr="Immagine che contiene bianco e nero, disegno, schizzo&#10;&#10;Descrizione generata automaticamente">
            <a:extLst>
              <a:ext uri="{FF2B5EF4-FFF2-40B4-BE49-F238E27FC236}">
                <a16:creationId xmlns:a16="http://schemas.microsoft.com/office/drawing/2014/main" id="{5A8118E6-1A68-DF60-032E-5718AEE3516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14501" y="3183360"/>
            <a:ext cx="3232226" cy="2427302"/>
          </a:xfrm>
          <a:prstGeom prst="rect">
            <a:avLst/>
          </a:prstGeom>
        </p:spPr>
      </p:pic>
      <p:pic>
        <p:nvPicPr>
          <p:cNvPr id="14" name="Immagine 13" descr="Immagine che contiene mappa, disegno, bianco e nero&#10;&#10;Descrizione generata automaticamente">
            <a:extLst>
              <a:ext uri="{FF2B5EF4-FFF2-40B4-BE49-F238E27FC236}">
                <a16:creationId xmlns:a16="http://schemas.microsoft.com/office/drawing/2014/main" id="{09B76335-3272-C135-47A5-DD7870789BE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14501" y="5682313"/>
            <a:ext cx="3232226" cy="2435826"/>
          </a:xfrm>
          <a:prstGeom prst="rect">
            <a:avLst/>
          </a:prstGeom>
        </p:spPr>
      </p:pic>
      <p:pic>
        <p:nvPicPr>
          <p:cNvPr id="11" name="Immagine 10" descr="Immagine che contiene schizzo, disegno, bianco e nero&#10;&#10;Descrizione generata automaticamente">
            <a:extLst>
              <a:ext uri="{FF2B5EF4-FFF2-40B4-BE49-F238E27FC236}">
                <a16:creationId xmlns:a16="http://schemas.microsoft.com/office/drawing/2014/main" id="{B67C34FD-0686-5B61-94E3-1580E7FF9ED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14501" y="673310"/>
            <a:ext cx="3232226" cy="2438400"/>
          </a:xfrm>
          <a:prstGeom prst="rect">
            <a:avLst/>
          </a:prstGeom>
        </p:spPr>
      </p:pic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193E6859-A683-7931-DE4A-D89883A68C4E}"/>
              </a:ext>
            </a:extLst>
          </p:cNvPr>
          <p:cNvSpPr txBox="1"/>
          <p:nvPr/>
        </p:nvSpPr>
        <p:spPr>
          <a:xfrm rot="16200000">
            <a:off x="1214684" y="1671100"/>
            <a:ext cx="6303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Lean</a:t>
            </a: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21558BA2-7E02-784C-8328-D94B6AF7B36D}"/>
              </a:ext>
            </a:extLst>
          </p:cNvPr>
          <p:cNvSpPr txBox="1"/>
          <p:nvPr/>
        </p:nvSpPr>
        <p:spPr>
          <a:xfrm rot="16200000">
            <a:off x="865037" y="4260580"/>
            <a:ext cx="13295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Lip. non-</a:t>
            </a:r>
            <a:r>
              <a:rPr lang="en-US" b="1" dirty="0" err="1"/>
              <a:t>aff</a:t>
            </a:r>
            <a:r>
              <a:rPr lang="en-US" b="1" dirty="0"/>
              <a:t> </a:t>
            </a: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39A6DA13-39BE-0711-7CEB-A3E2E61E0077}"/>
              </a:ext>
            </a:extLst>
          </p:cNvPr>
          <p:cNvSpPr txBox="1"/>
          <p:nvPr/>
        </p:nvSpPr>
        <p:spPr>
          <a:xfrm rot="16200000">
            <a:off x="1072017" y="6756744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Obesity</a:t>
            </a:r>
          </a:p>
        </p:txBody>
      </p:sp>
      <p:sp>
        <p:nvSpPr>
          <p:cNvPr id="2" name="CasellaDiTesto 1">
            <a:extLst>
              <a:ext uri="{FF2B5EF4-FFF2-40B4-BE49-F238E27FC236}">
                <a16:creationId xmlns:a16="http://schemas.microsoft.com/office/drawing/2014/main" id="{3D9786C7-FE81-D2E7-A2C3-5F435C368E09}"/>
              </a:ext>
            </a:extLst>
          </p:cNvPr>
          <p:cNvSpPr txBox="1"/>
          <p:nvPr/>
        </p:nvSpPr>
        <p:spPr>
          <a:xfrm>
            <a:off x="2980999" y="6756745"/>
            <a:ext cx="699230" cy="36933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900" b="1" dirty="0">
                <a:solidFill>
                  <a:schemeClr val="bg1"/>
                </a:solidFill>
              </a:rPr>
              <a:t>CAPILLARY</a:t>
            </a:r>
          </a:p>
          <a:p>
            <a:pPr algn="ctr"/>
            <a:r>
              <a:rPr lang="it-IT" sz="900" b="1" dirty="0">
                <a:solidFill>
                  <a:schemeClr val="bg1"/>
                </a:solidFill>
              </a:rPr>
              <a:t>LUMEN</a:t>
            </a:r>
          </a:p>
        </p:txBody>
      </p:sp>
      <p:sp>
        <p:nvSpPr>
          <p:cNvPr id="3" name="CasellaDiTesto 2">
            <a:extLst>
              <a:ext uri="{FF2B5EF4-FFF2-40B4-BE49-F238E27FC236}">
                <a16:creationId xmlns:a16="http://schemas.microsoft.com/office/drawing/2014/main" id="{19F73252-A42E-3633-9A07-3E7CB8E7BB76}"/>
              </a:ext>
            </a:extLst>
          </p:cNvPr>
          <p:cNvSpPr txBox="1"/>
          <p:nvPr/>
        </p:nvSpPr>
        <p:spPr>
          <a:xfrm>
            <a:off x="2722197" y="4445247"/>
            <a:ext cx="699230" cy="36933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900" b="1" dirty="0"/>
              <a:t>CAPILLARY</a:t>
            </a:r>
          </a:p>
          <a:p>
            <a:pPr algn="ctr"/>
            <a:r>
              <a:rPr lang="it-IT" sz="900" b="1" dirty="0"/>
              <a:t>LUMEN</a:t>
            </a:r>
          </a:p>
        </p:txBody>
      </p: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9057642B-1B72-69F9-A9D5-18DD136EBB78}"/>
              </a:ext>
            </a:extLst>
          </p:cNvPr>
          <p:cNvSpPr txBox="1"/>
          <p:nvPr/>
        </p:nvSpPr>
        <p:spPr>
          <a:xfrm>
            <a:off x="3071812" y="1523177"/>
            <a:ext cx="699230" cy="36933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900" b="1" dirty="0"/>
              <a:t>CAPILLARY</a:t>
            </a:r>
          </a:p>
          <a:p>
            <a:pPr algn="ctr"/>
            <a:r>
              <a:rPr lang="it-IT" sz="900" b="1" dirty="0"/>
              <a:t>LUMEN</a:t>
            </a:r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2536D744-3205-D153-F3DB-0DCA8D4C539D}"/>
              </a:ext>
            </a:extLst>
          </p:cNvPr>
          <p:cNvSpPr txBox="1"/>
          <p:nvPr/>
        </p:nvSpPr>
        <p:spPr>
          <a:xfrm rot="1391152">
            <a:off x="3350537" y="3527072"/>
            <a:ext cx="63190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b="1" dirty="0"/>
              <a:t>PERICYTE</a:t>
            </a: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B7634E10-FD40-9D62-2614-662D4152840C}"/>
              </a:ext>
            </a:extLst>
          </p:cNvPr>
          <p:cNvSpPr txBox="1"/>
          <p:nvPr/>
        </p:nvSpPr>
        <p:spPr>
          <a:xfrm>
            <a:off x="3861632" y="7678459"/>
            <a:ext cx="63190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b="1" dirty="0">
                <a:solidFill>
                  <a:schemeClr val="bg1"/>
                </a:solidFill>
              </a:rPr>
              <a:t>PERICYTE</a:t>
            </a: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2853BC2B-0648-70A9-73E5-4A1CF7346715}"/>
              </a:ext>
            </a:extLst>
          </p:cNvPr>
          <p:cNvSpPr txBox="1"/>
          <p:nvPr/>
        </p:nvSpPr>
        <p:spPr>
          <a:xfrm rot="19516234">
            <a:off x="1829804" y="6048145"/>
            <a:ext cx="63190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b="1" dirty="0"/>
              <a:t>PERICYTE</a:t>
            </a: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5F8A5B2B-D105-3870-FC11-F3CB255E4594}"/>
              </a:ext>
            </a:extLst>
          </p:cNvPr>
          <p:cNvSpPr txBox="1"/>
          <p:nvPr/>
        </p:nvSpPr>
        <p:spPr>
          <a:xfrm>
            <a:off x="0" y="0"/>
            <a:ext cx="766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cs typeface="Calibri" panose="020F0502020204030204" pitchFamily="34" charset="0"/>
              </a:rPr>
              <a:t>Figure S2</a:t>
            </a:r>
          </a:p>
        </p:txBody>
      </p:sp>
    </p:spTree>
    <p:extLst>
      <p:ext uri="{BB962C8B-B14F-4D97-AF65-F5344CB8AC3E}">
        <p14:creationId xmlns:p14="http://schemas.microsoft.com/office/powerpoint/2010/main" val="313215570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ttangolo 3"/>
          <p:cNvSpPr/>
          <p:nvPr/>
        </p:nvSpPr>
        <p:spPr>
          <a:xfrm>
            <a:off x="0" y="2859932"/>
            <a:ext cx="6143625" cy="3414408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9" name="CasellaDiTesto 28">
            <a:extLst>
              <a:ext uri="{FF2B5EF4-FFF2-40B4-BE49-F238E27FC236}">
                <a16:creationId xmlns:a16="http://schemas.microsoft.com/office/drawing/2014/main" id="{D5B177AF-4FA1-2636-097F-0DCEA8697111}"/>
              </a:ext>
            </a:extLst>
          </p:cNvPr>
          <p:cNvSpPr txBox="1"/>
          <p:nvPr/>
        </p:nvSpPr>
        <p:spPr>
          <a:xfrm>
            <a:off x="19838" y="-19546"/>
            <a:ext cx="766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cs typeface="Calibri" panose="020F0502020204030204" pitchFamily="34" charset="0"/>
              </a:rPr>
              <a:t>Figure S3</a:t>
            </a:r>
          </a:p>
        </p:txBody>
      </p:sp>
      <p:pic>
        <p:nvPicPr>
          <p:cNvPr id="6" name="Immagine 5" descr="Immagine che contiene mappa&#10;&#10;Descrizione generata automaticamente">
            <a:extLst>
              <a:ext uri="{FF2B5EF4-FFF2-40B4-BE49-F238E27FC236}">
                <a16:creationId xmlns:a16="http://schemas.microsoft.com/office/drawing/2014/main" id="{20BA3718-B159-E77E-8C4C-EAA69E630FA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1920" y="2953544"/>
            <a:ext cx="5913120" cy="3227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188643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30</TotalTime>
  <Words>20</Words>
  <Application>Microsoft Macintosh PowerPoint</Application>
  <PresentationFormat>Personalizzato</PresentationFormat>
  <Paragraphs>15</Paragraphs>
  <Slides>3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Tema di Office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di PowerPoint</dc:title>
  <dc:creator>SAVERIO CINTI</dc:creator>
  <cp:lastModifiedBy>Stefania Greco</cp:lastModifiedBy>
  <cp:revision>68</cp:revision>
  <dcterms:created xsi:type="dcterms:W3CDTF">2023-10-13T08:44:43Z</dcterms:created>
  <dcterms:modified xsi:type="dcterms:W3CDTF">2025-01-10T11:20:11Z</dcterms:modified>
</cp:coreProperties>
</file>